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44" d="100"/>
          <a:sy n="44" d="100"/>
        </p:scale>
        <p:origin x="2256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nfacon, Helene (AAFC/AAC)" userId="72064665-392b-46b2-86df-11307443f336" providerId="ADAL" clId="{847B7621-F7BA-49B9-BFF2-C06B831B4A0D}"/>
    <pc:docChg chg="modSld">
      <pc:chgData name="Sanfacon, Helene (AAFC/AAC)" userId="72064665-392b-46b2-86df-11307443f336" providerId="ADAL" clId="{847B7621-F7BA-49B9-BFF2-C06B831B4A0D}" dt="2025-06-12T19:18:53.296" v="8" actId="20577"/>
      <pc:docMkLst>
        <pc:docMk/>
      </pc:docMkLst>
      <pc:sldChg chg="modSp mod">
        <pc:chgData name="Sanfacon, Helene (AAFC/AAC)" userId="72064665-392b-46b2-86df-11307443f336" providerId="ADAL" clId="{847B7621-F7BA-49B9-BFF2-C06B831B4A0D}" dt="2025-06-12T19:18:53.296" v="8" actId="20577"/>
        <pc:sldMkLst>
          <pc:docMk/>
          <pc:sldMk cId="650844377" sldId="256"/>
        </pc:sldMkLst>
        <pc:spChg chg="mod">
          <ac:chgData name="Sanfacon, Helene (AAFC/AAC)" userId="72064665-392b-46b2-86df-11307443f336" providerId="ADAL" clId="{847B7621-F7BA-49B9-BFF2-C06B831B4A0D}" dt="2025-06-12T19:18:53.296" v="8" actId="20577"/>
          <ac:spMkLst>
            <pc:docMk/>
            <pc:sldMk cId="650844377" sldId="256"/>
            <ac:spMk id="7" creationId="{974EC187-E572-57A4-158A-3CDD5FE62CB1}"/>
          </ac:spMkLst>
        </pc:spChg>
      </pc:sldChg>
    </pc:docChg>
  </pc:docChgLst>
  <pc:docChgLst>
    <pc:chgData name="Sanfacon, Helene (AAFC/AAC)" userId="72064665-392b-46b2-86df-11307443f336" providerId="ADAL" clId="{E6400DD3-5F06-497B-BB8A-40327D1B9CF6}"/>
    <pc:docChg chg="modSld">
      <pc:chgData name="Sanfacon, Helene (AAFC/AAC)" userId="72064665-392b-46b2-86df-11307443f336" providerId="ADAL" clId="{E6400DD3-5F06-497B-BB8A-40327D1B9CF6}" dt="2025-04-14T22:07:45.347" v="14" actId="20577"/>
      <pc:docMkLst>
        <pc:docMk/>
      </pc:docMkLst>
      <pc:sldChg chg="modSp mod">
        <pc:chgData name="Sanfacon, Helene (AAFC/AAC)" userId="72064665-392b-46b2-86df-11307443f336" providerId="ADAL" clId="{E6400DD3-5F06-497B-BB8A-40327D1B9CF6}" dt="2025-04-14T22:07:45.347" v="14" actId="20577"/>
        <pc:sldMkLst>
          <pc:docMk/>
          <pc:sldMk cId="650844377" sldId="256"/>
        </pc:sldMkLst>
        <pc:spChg chg="mod">
          <ac:chgData name="Sanfacon, Helene (AAFC/AAC)" userId="72064665-392b-46b2-86df-11307443f336" providerId="ADAL" clId="{E6400DD3-5F06-497B-BB8A-40327D1B9CF6}" dt="2025-04-14T22:07:45.347" v="14" actId="20577"/>
          <ac:spMkLst>
            <pc:docMk/>
            <pc:sldMk cId="650844377" sldId="256"/>
            <ac:spMk id="7" creationId="{974EC187-E572-57A4-158A-3CDD5FE62CB1}"/>
          </ac:spMkLst>
        </pc:spChg>
      </pc:sldChg>
    </pc:docChg>
  </pc:docChgLst>
  <pc:docChgLst>
    <pc:chgData name="Sanfacon, Helene (AAFC/AAC)" userId="72064665-392b-46b2-86df-11307443f336" providerId="ADAL" clId="{DB7D38CD-D57D-4450-B2D1-B6E44E320F3F}"/>
    <pc:docChg chg="modSld">
      <pc:chgData name="Sanfacon, Helene (AAFC/AAC)" userId="72064665-392b-46b2-86df-11307443f336" providerId="ADAL" clId="{DB7D38CD-D57D-4450-B2D1-B6E44E320F3F}" dt="2025-04-10T15:31:21.928" v="5" actId="14100"/>
      <pc:docMkLst>
        <pc:docMk/>
      </pc:docMkLst>
      <pc:sldChg chg="addSp modSp mod">
        <pc:chgData name="Sanfacon, Helene (AAFC/AAC)" userId="72064665-392b-46b2-86df-11307443f336" providerId="ADAL" clId="{DB7D38CD-D57D-4450-B2D1-B6E44E320F3F}" dt="2025-04-10T15:31:21.928" v="5" actId="14100"/>
        <pc:sldMkLst>
          <pc:docMk/>
          <pc:sldMk cId="650844377" sldId="256"/>
        </pc:sldMkLst>
        <pc:spChg chg="add mod">
          <ac:chgData name="Sanfacon, Helene (AAFC/AAC)" userId="72064665-392b-46b2-86df-11307443f336" providerId="ADAL" clId="{DB7D38CD-D57D-4450-B2D1-B6E44E320F3F}" dt="2025-04-10T15:31:21.928" v="5" actId="14100"/>
          <ac:spMkLst>
            <pc:docMk/>
            <pc:sldMk cId="650844377" sldId="256"/>
            <ac:spMk id="2" creationId="{FA27AD2C-E8AF-3B13-0526-328DD7839B1A}"/>
          </ac:spMkLst>
        </pc:spChg>
        <pc:spChg chg="mod">
          <ac:chgData name="Sanfacon, Helene (AAFC/AAC)" userId="72064665-392b-46b2-86df-11307443f336" providerId="ADAL" clId="{DB7D38CD-D57D-4450-B2D1-B6E44E320F3F}" dt="2025-04-10T15:30:59.788" v="4" actId="6549"/>
          <ac:spMkLst>
            <pc:docMk/>
            <pc:sldMk cId="650844377" sldId="256"/>
            <ac:spMk id="7" creationId="{974EC187-E572-57A4-158A-3CDD5FE62CB1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001gc-my.sharepoint.com/personal/helene_sanfacon_agr_gc_ca/Documents/Desktop/ddPCR%20validation%20of%20ToRSV%20transcriptomic/normalization%20of%20ddPCR%20validation%20assay%20for%20ToRSV%20transcriptomic%20with%20PP2A%20reference%20gene-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001gc-my.sharepoint.com/personal/helene_sanfacon_agr_gc_ca/Documents/Desktop/ddPCR%20validation%20of%20ToRSV%20transcriptomic/normalization%20of%20ddPCR%20validation%20assay%20for%20ToRSV%20transcriptomic%20with%20PP2A%20reference%20gene-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nfaconh\AppData\Roaming\Microsoft\Excel\normalization%20of%20ddPCR%20validation%20assay%20for%20ToRSV%20transcriptomic%20with%20various%20reference%20genes%20simplified%20(version%201).xlsb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r>
              <a:rPr lang="en-US" sz="900" b="0" i="0" u="none" strike="noStrike" kern="1200" spc="0" baseline="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</c:rich>
      </c:tx>
      <c:layout>
        <c:manualLayout>
          <c:xMode val="edge"/>
          <c:yMode val="edge"/>
          <c:x val="0.41553690565965234"/>
          <c:y val="5.15170970412898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ctin!$I$16:$I$23</c:f>
                <c:numCache>
                  <c:formatCode>General</c:formatCode>
                  <c:ptCount val="8"/>
                  <c:pt idx="0">
                    <c:v>7.4432292756478696E-2</c:v>
                  </c:pt>
                  <c:pt idx="1">
                    <c:v>3.4062235668219067E-2</c:v>
                  </c:pt>
                  <c:pt idx="2">
                    <c:v>8.2001678460527375E-2</c:v>
                  </c:pt>
                  <c:pt idx="3">
                    <c:v>8.5786371312551707E-2</c:v>
                  </c:pt>
                  <c:pt idx="4">
                    <c:v>3.9440218870962808E-2</c:v>
                  </c:pt>
                  <c:pt idx="5">
                    <c:v>2.0659162265742426E-2</c:v>
                  </c:pt>
                  <c:pt idx="6">
                    <c:v>4.6952641513050966E-2</c:v>
                  </c:pt>
                  <c:pt idx="7">
                    <c:v>2.817158490783058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ctin!$G$16:$G$23</c:f>
              <c:strCache>
                <c:ptCount val="8"/>
                <c:pt idx="0">
                  <c:v>MK3</c:v>
                </c:pt>
                <c:pt idx="1">
                  <c:v>Inoc3</c:v>
                </c:pt>
                <c:pt idx="2">
                  <c:v>MK10</c:v>
                </c:pt>
                <c:pt idx="3">
                  <c:v>Rec10</c:v>
                </c:pt>
                <c:pt idx="4">
                  <c:v>R5_MK3</c:v>
                </c:pt>
                <c:pt idx="5">
                  <c:v>R5_R3</c:v>
                </c:pt>
                <c:pt idx="6">
                  <c:v>R5_MK10</c:v>
                </c:pt>
                <c:pt idx="7">
                  <c:v>R5_Rasp10</c:v>
                </c:pt>
              </c:strCache>
            </c:strRef>
          </c:cat>
          <c:val>
            <c:numRef>
              <c:f>Actin!$H$16:$H$23</c:f>
              <c:numCache>
                <c:formatCode>0.00</c:formatCode>
                <c:ptCount val="8"/>
                <c:pt idx="0">
                  <c:v>1</c:v>
                </c:pt>
                <c:pt idx="1">
                  <c:v>0.32917038358608386</c:v>
                </c:pt>
                <c:pt idx="2">
                  <c:v>1.2479928635147191</c:v>
                </c:pt>
                <c:pt idx="3">
                  <c:v>1.3880463871543265</c:v>
                </c:pt>
                <c:pt idx="4">
                  <c:v>1</c:v>
                </c:pt>
                <c:pt idx="5">
                  <c:v>0.71049136786188583</c:v>
                </c:pt>
                <c:pt idx="6">
                  <c:v>1.345285524568393</c:v>
                </c:pt>
                <c:pt idx="7">
                  <c:v>1.73041168658698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A0-4B2A-99C1-F02E622058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5648335"/>
        <c:axId val="975646415"/>
      </c:barChart>
      <c:catAx>
        <c:axId val="97564833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75646415"/>
        <c:crosses val="autoZero"/>
        <c:auto val="1"/>
        <c:lblAlgn val="ctr"/>
        <c:lblOffset val="100"/>
        <c:noMultiLvlLbl val="0"/>
      </c:catAx>
      <c:valAx>
        <c:axId val="975646415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crossAx val="9756483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r>
              <a:rPr lang="en-US" sz="9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P2A</a:t>
            </a:r>
          </a:p>
        </c:rich>
      </c:tx>
      <c:layout>
        <c:manualLayout>
          <c:xMode val="edge"/>
          <c:yMode val="edge"/>
          <c:x val="0.43490271177736028"/>
          <c:y val="5.25125389192340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P2A!$I$49:$I$56</c:f>
                <c:numCache>
                  <c:formatCode>General</c:formatCode>
                  <c:ptCount val="8"/>
                  <c:pt idx="0">
                    <c:v>0.12131425334693513</c:v>
                  </c:pt>
                  <c:pt idx="1">
                    <c:v>0.26403690434332944</c:v>
                  </c:pt>
                  <c:pt idx="2">
                    <c:v>2.8544530199278852E-2</c:v>
                  </c:pt>
                  <c:pt idx="3">
                    <c:v>5.2051790363390853E-2</c:v>
                  </c:pt>
                  <c:pt idx="4">
                    <c:v>0.11195625287002448</c:v>
                  </c:pt>
                  <c:pt idx="5">
                    <c:v>8.3549442440316755E-4</c:v>
                  </c:pt>
                  <c:pt idx="6">
                    <c:v>5.6535122717947674E-2</c:v>
                  </c:pt>
                  <c:pt idx="7">
                    <c:v>3.73187509566748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P2A!$G$49:$G$56</c:f>
              <c:strCache>
                <c:ptCount val="8"/>
                <c:pt idx="0">
                  <c:v>MK3</c:v>
                </c:pt>
                <c:pt idx="1">
                  <c:v>Inoc3</c:v>
                </c:pt>
                <c:pt idx="2">
                  <c:v>MK10</c:v>
                </c:pt>
                <c:pt idx="3">
                  <c:v>Rec10</c:v>
                </c:pt>
                <c:pt idx="4">
                  <c:v>R5_MK3</c:v>
                </c:pt>
                <c:pt idx="5">
                  <c:v>R5_R3</c:v>
                </c:pt>
                <c:pt idx="6">
                  <c:v>R5_MK10</c:v>
                </c:pt>
                <c:pt idx="7">
                  <c:v>R5_Rasp10</c:v>
                </c:pt>
              </c:strCache>
            </c:strRef>
          </c:cat>
          <c:val>
            <c:numRef>
              <c:f>PP2A!$H$49:$H$56</c:f>
              <c:numCache>
                <c:formatCode>0.00</c:formatCode>
                <c:ptCount val="8"/>
                <c:pt idx="0">
                  <c:v>1</c:v>
                </c:pt>
                <c:pt idx="1">
                  <c:v>1.964677945978035</c:v>
                </c:pt>
                <c:pt idx="2">
                  <c:v>0.85663401602849509</c:v>
                </c:pt>
                <c:pt idx="3">
                  <c:v>1.0733155238943306</c:v>
                </c:pt>
                <c:pt idx="4">
                  <c:v>1</c:v>
                </c:pt>
                <c:pt idx="5">
                  <c:v>2.2640803465931469</c:v>
                </c:pt>
                <c:pt idx="6">
                  <c:v>0.75561244584482079</c:v>
                </c:pt>
                <c:pt idx="7">
                  <c:v>1.07955888144938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69-405A-AB8B-30260F2A36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6977967"/>
        <c:axId val="1700676895"/>
      </c:barChart>
      <c:catAx>
        <c:axId val="155697796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00676895"/>
        <c:crosses val="autoZero"/>
        <c:auto val="1"/>
        <c:lblAlgn val="ctr"/>
        <c:lblOffset val="100"/>
        <c:noMultiLvlLbl val="0"/>
      </c:catAx>
      <c:valAx>
        <c:axId val="1700676895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crossAx val="15569779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r>
              <a:rPr lang="en-US" sz="900" b="0" i="0" u="none" strike="noStrike" kern="1200" spc="0" baseline="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bined PP2A and actin</a:t>
            </a:r>
          </a:p>
        </c:rich>
      </c:tx>
      <c:layout>
        <c:manualLayout>
          <c:xMode val="edge"/>
          <c:yMode val="edge"/>
          <c:x val="0.21051338061060701"/>
          <c:y val="4.52821658917260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2A + Actin'!$L$26:$L$33</c:f>
                <c:numCache>
                  <c:formatCode>General</c:formatCode>
                  <c:ptCount val="8"/>
                  <c:pt idx="0">
                    <c:v>0.14232819211284359</c:v>
                  </c:pt>
                  <c:pt idx="1">
                    <c:v>0.15662119553256959</c:v>
                  </c:pt>
                  <c:pt idx="2">
                    <c:v>8.1467847796155304E-2</c:v>
                  </c:pt>
                  <c:pt idx="3">
                    <c:v>0.10006082538236991</c:v>
                  </c:pt>
                  <c:pt idx="4">
                    <c:v>0.11870018290333977</c:v>
                  </c:pt>
                  <c:pt idx="5">
                    <c:v>4.6028248073721779E-2</c:v>
                  </c:pt>
                  <c:pt idx="6">
                    <c:v>8.3731192998006521E-2</c:v>
                  </c:pt>
                  <c:pt idx="7">
                    <c:v>5.21554499258321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P2A + Actin'!$J$26:$J$33</c:f>
              <c:strCache>
                <c:ptCount val="8"/>
                <c:pt idx="0">
                  <c:v>MK3</c:v>
                </c:pt>
                <c:pt idx="1">
                  <c:v>Inoc3</c:v>
                </c:pt>
                <c:pt idx="2">
                  <c:v>MK10</c:v>
                </c:pt>
                <c:pt idx="3">
                  <c:v>Rec10</c:v>
                </c:pt>
                <c:pt idx="4">
                  <c:v>R5_MK3</c:v>
                </c:pt>
                <c:pt idx="5">
                  <c:v>R5_R3</c:v>
                </c:pt>
                <c:pt idx="6">
                  <c:v>R5_MK10</c:v>
                </c:pt>
                <c:pt idx="7">
                  <c:v>R5_Rasp10</c:v>
                </c:pt>
              </c:strCache>
            </c:strRef>
          </c:cat>
          <c:val>
            <c:numRef>
              <c:f>'PP2A + Actin'!$K$26:$K$33</c:f>
              <c:numCache>
                <c:formatCode>0.00</c:formatCode>
                <c:ptCount val="8"/>
                <c:pt idx="0">
                  <c:v>1</c:v>
                </c:pt>
                <c:pt idx="1">
                  <c:v>0.92339460084354319</c:v>
                </c:pt>
                <c:pt idx="2">
                  <c:v>1.1058015889759647</c:v>
                </c:pt>
                <c:pt idx="3">
                  <c:v>1.2736961357902086</c:v>
                </c:pt>
                <c:pt idx="4">
                  <c:v>1</c:v>
                </c:pt>
                <c:pt idx="5">
                  <c:v>1.5828347363369546</c:v>
                </c:pt>
                <c:pt idx="6">
                  <c:v>1.0141828926400511</c:v>
                </c:pt>
                <c:pt idx="7">
                  <c:v>1.3649565139589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D1-47DE-81B1-BCCE69C770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08064576"/>
        <c:axId val="2008066496"/>
      </c:barChart>
      <c:catAx>
        <c:axId val="20080645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08066496"/>
        <c:crosses val="autoZero"/>
        <c:auto val="1"/>
        <c:lblAlgn val="ctr"/>
        <c:lblOffset val="100"/>
        <c:noMultiLvlLbl val="0"/>
      </c:catAx>
      <c:valAx>
        <c:axId val="2008066496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crossAx val="2008064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09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24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300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0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24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04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848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60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529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360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366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230451-F0C3-494F-8A95-35899EF4B55D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757A8D8-B60D-4ACB-80C7-22F0F29BCCB3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471FC8-6BAB-26CF-E836-12186DBDC1E6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429250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US" sz="10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30558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42E2F7A-598A-04ED-6914-F19AAED254AD}"/>
              </a:ext>
            </a:extLst>
          </p:cNvPr>
          <p:cNvGraphicFramePr>
            <a:graphicFrameLocks/>
          </p:cNvGraphicFramePr>
          <p:nvPr/>
        </p:nvGraphicFramePr>
        <p:xfrm>
          <a:off x="2596228" y="2438017"/>
          <a:ext cx="1665544" cy="146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9626998-C928-A5AC-54F2-A9F72AD739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1154925"/>
              </p:ext>
            </p:extLst>
          </p:nvPr>
        </p:nvGraphicFramePr>
        <p:xfrm>
          <a:off x="628759" y="2449501"/>
          <a:ext cx="1701799" cy="1451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5B559C4-200C-B690-643F-6760FA235315}"/>
              </a:ext>
            </a:extLst>
          </p:cNvPr>
          <p:cNvCxnSpPr>
            <a:cxnSpLocks/>
          </p:cNvCxnSpPr>
          <p:nvPr/>
        </p:nvCxnSpPr>
        <p:spPr>
          <a:xfrm flipH="1">
            <a:off x="1494479" y="2829720"/>
            <a:ext cx="6328" cy="9299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74EC187-E572-57A4-158A-3CDD5FE62CB1}"/>
              </a:ext>
            </a:extLst>
          </p:cNvPr>
          <p:cNvSpPr txBox="1"/>
          <p:nvPr/>
        </p:nvSpPr>
        <p:spPr>
          <a:xfrm>
            <a:off x="493075" y="5061621"/>
            <a:ext cx="611283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3 Fig. Selection of reference genes for </a:t>
            </a:r>
            <a:r>
              <a:rPr lang="en-CA" sz="9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dPCR</a:t>
            </a:r>
            <a:r>
              <a:rPr lang="en-CA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alidation. </a:t>
            </a:r>
            <a:r>
              <a:rPr lang="en-CA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tal RNA samples  extracted from mock-inoculated leaves at 3 dpi (M3) or 10 dpi (M10) or from symptomatic (S3) or recovered leaves (R10) were diluted 1:20 and tested by </a:t>
            </a:r>
            <a:r>
              <a:rPr lang="en-CA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dPCR</a:t>
            </a:r>
            <a:r>
              <a:rPr lang="en-CA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Values are reported as fold change compared to the M3 sample for each biological repeat which were set at 1.  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A6ABFE67-0777-F5A3-441C-F8DA367704BB}"/>
              </a:ext>
            </a:extLst>
          </p:cNvPr>
          <p:cNvGraphicFramePr>
            <a:graphicFrameLocks/>
          </p:cNvGraphicFramePr>
          <p:nvPr/>
        </p:nvGraphicFramePr>
        <p:xfrm>
          <a:off x="4563234" y="2438017"/>
          <a:ext cx="1693631" cy="146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23EE4AB-BD8B-ECBF-B913-05563347A882}"/>
              </a:ext>
            </a:extLst>
          </p:cNvPr>
          <p:cNvCxnSpPr>
            <a:cxnSpLocks/>
          </p:cNvCxnSpPr>
          <p:nvPr/>
        </p:nvCxnSpPr>
        <p:spPr>
          <a:xfrm flipH="1">
            <a:off x="3422308" y="2829720"/>
            <a:ext cx="6328" cy="9299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0CC7098-49EB-561E-1657-8EB72CF7CA20}"/>
              </a:ext>
            </a:extLst>
          </p:cNvPr>
          <p:cNvCxnSpPr>
            <a:cxnSpLocks/>
          </p:cNvCxnSpPr>
          <p:nvPr/>
        </p:nvCxnSpPr>
        <p:spPr>
          <a:xfrm flipH="1">
            <a:off x="5410768" y="2829720"/>
            <a:ext cx="6328" cy="9299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F0249A8-8C10-C1F5-BC9F-56B39222A3C8}"/>
              </a:ext>
            </a:extLst>
          </p:cNvPr>
          <p:cNvSpPr txBox="1"/>
          <p:nvPr/>
        </p:nvSpPr>
        <p:spPr>
          <a:xfrm>
            <a:off x="575989" y="2590851"/>
            <a:ext cx="235962" cy="12736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</a:p>
          <a:p>
            <a:pPr algn="r">
              <a:lnSpc>
                <a:spcPct val="25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  <a:p>
            <a:pPr algn="r">
              <a:lnSpc>
                <a:spcPct val="25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  <a:p>
            <a:pPr algn="r">
              <a:lnSpc>
                <a:spcPct val="25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D32B93-074C-FA2D-D1A1-1FE0AF50096E}"/>
              </a:ext>
            </a:extLst>
          </p:cNvPr>
          <p:cNvSpPr txBox="1"/>
          <p:nvPr/>
        </p:nvSpPr>
        <p:spPr>
          <a:xfrm>
            <a:off x="2456441" y="2610925"/>
            <a:ext cx="312906" cy="12890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  <a:p>
            <a:pPr algn="r">
              <a:lnSpc>
                <a:spcPct val="20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5</a:t>
            </a:r>
          </a:p>
          <a:p>
            <a:pPr algn="r">
              <a:lnSpc>
                <a:spcPct val="20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  <a:p>
            <a:pPr algn="r">
              <a:lnSpc>
                <a:spcPct val="20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5</a:t>
            </a:r>
          </a:p>
          <a:p>
            <a:pPr algn="r">
              <a:lnSpc>
                <a:spcPct val="200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CA8732-2F44-CEB0-6649-59645892328E}"/>
              </a:ext>
            </a:extLst>
          </p:cNvPr>
          <p:cNvSpPr txBox="1"/>
          <p:nvPr/>
        </p:nvSpPr>
        <p:spPr>
          <a:xfrm>
            <a:off x="4438535" y="2603670"/>
            <a:ext cx="312906" cy="12890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9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  <a:p>
            <a:pPr algn="r">
              <a:lnSpc>
                <a:spcPct val="19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5</a:t>
            </a:r>
          </a:p>
          <a:p>
            <a:pPr algn="r">
              <a:lnSpc>
                <a:spcPct val="19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  <a:p>
            <a:pPr algn="r">
              <a:lnSpc>
                <a:spcPct val="19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5</a:t>
            </a:r>
          </a:p>
          <a:p>
            <a:pPr algn="r">
              <a:lnSpc>
                <a:spcPct val="19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80E7C2-9068-5D99-6BC6-9CDFF1F465E1}"/>
              </a:ext>
            </a:extLst>
          </p:cNvPr>
          <p:cNvSpPr txBox="1"/>
          <p:nvPr/>
        </p:nvSpPr>
        <p:spPr>
          <a:xfrm rot="16200000">
            <a:off x="149071" y="3147705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ld change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6F65087-030E-0E7A-ED40-340CE2227327}"/>
              </a:ext>
            </a:extLst>
          </p:cNvPr>
          <p:cNvCxnSpPr>
            <a:cxnSpLocks/>
          </p:cNvCxnSpPr>
          <p:nvPr/>
        </p:nvCxnSpPr>
        <p:spPr>
          <a:xfrm>
            <a:off x="1567594" y="4130559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74422FC-EE09-1668-D209-0E5324DFE817}"/>
              </a:ext>
            </a:extLst>
          </p:cNvPr>
          <p:cNvSpPr txBox="1"/>
          <p:nvPr/>
        </p:nvSpPr>
        <p:spPr>
          <a:xfrm>
            <a:off x="750049" y="4113294"/>
            <a:ext cx="1517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eat 3                 Repeat 4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EA5C390-69B2-CB4C-3BC0-6600B730C066}"/>
              </a:ext>
            </a:extLst>
          </p:cNvPr>
          <p:cNvCxnSpPr>
            <a:cxnSpLocks/>
          </p:cNvCxnSpPr>
          <p:nvPr/>
        </p:nvCxnSpPr>
        <p:spPr>
          <a:xfrm>
            <a:off x="804094" y="4130559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78F9EBC-AFC3-A65C-1FF4-3B3AEF6EDBF5}"/>
              </a:ext>
            </a:extLst>
          </p:cNvPr>
          <p:cNvSpPr txBox="1"/>
          <p:nvPr/>
        </p:nvSpPr>
        <p:spPr>
          <a:xfrm rot="16200000">
            <a:off x="1296366" y="3227345"/>
            <a:ext cx="397866" cy="1502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D5EF4D9-760A-E95D-55DE-4B86B5C467B4}"/>
              </a:ext>
            </a:extLst>
          </p:cNvPr>
          <p:cNvCxnSpPr>
            <a:cxnSpLocks/>
          </p:cNvCxnSpPr>
          <p:nvPr/>
        </p:nvCxnSpPr>
        <p:spPr>
          <a:xfrm>
            <a:off x="3520434" y="4128283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69A9996B-951F-57A8-E079-40687D6DE634}"/>
              </a:ext>
            </a:extLst>
          </p:cNvPr>
          <p:cNvSpPr txBox="1"/>
          <p:nvPr/>
        </p:nvSpPr>
        <p:spPr>
          <a:xfrm>
            <a:off x="2702889" y="4111018"/>
            <a:ext cx="1517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eat 3                 Repeat 4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23D72AC-104D-C802-375A-41A6764FC892}"/>
              </a:ext>
            </a:extLst>
          </p:cNvPr>
          <p:cNvCxnSpPr>
            <a:cxnSpLocks/>
          </p:cNvCxnSpPr>
          <p:nvPr/>
        </p:nvCxnSpPr>
        <p:spPr>
          <a:xfrm>
            <a:off x="2756934" y="4128283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FD142858-2A7B-D0CC-A036-B88E93FE05BD}"/>
              </a:ext>
            </a:extLst>
          </p:cNvPr>
          <p:cNvSpPr txBox="1"/>
          <p:nvPr/>
        </p:nvSpPr>
        <p:spPr>
          <a:xfrm rot="16200000">
            <a:off x="3236264" y="3227346"/>
            <a:ext cx="397866" cy="1502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12F90AE-91A2-D5A3-0491-208054BAC046}"/>
              </a:ext>
            </a:extLst>
          </p:cNvPr>
          <p:cNvCxnSpPr>
            <a:cxnSpLocks/>
          </p:cNvCxnSpPr>
          <p:nvPr/>
        </p:nvCxnSpPr>
        <p:spPr>
          <a:xfrm>
            <a:off x="5473274" y="4114585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8017E5B-5924-7FCA-305A-BB138BF252BC}"/>
              </a:ext>
            </a:extLst>
          </p:cNvPr>
          <p:cNvSpPr txBox="1"/>
          <p:nvPr/>
        </p:nvSpPr>
        <p:spPr>
          <a:xfrm>
            <a:off x="4655729" y="4097320"/>
            <a:ext cx="1517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eat 3                 Repeat 4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42DC44F9-0E0F-3E59-8064-2FF5D9518150}"/>
              </a:ext>
            </a:extLst>
          </p:cNvPr>
          <p:cNvCxnSpPr>
            <a:cxnSpLocks/>
          </p:cNvCxnSpPr>
          <p:nvPr/>
        </p:nvCxnSpPr>
        <p:spPr>
          <a:xfrm>
            <a:off x="4709774" y="4114585"/>
            <a:ext cx="6791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A2A1CBB1-5E29-BB25-3E74-84CFD2161BEB}"/>
              </a:ext>
            </a:extLst>
          </p:cNvPr>
          <p:cNvSpPr txBox="1"/>
          <p:nvPr/>
        </p:nvSpPr>
        <p:spPr>
          <a:xfrm rot="16200000">
            <a:off x="5189104" y="3200948"/>
            <a:ext cx="397866" cy="1502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 3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 10</a:t>
            </a:r>
          </a:p>
          <a:p>
            <a:pPr algn="r">
              <a:lnSpc>
                <a:spcPct val="145000"/>
              </a:lnSpc>
            </a:pPr>
            <a:r>
              <a:rPr lang="en-CA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 1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A27AD2C-E8AF-3B13-0526-328DD7839B1A}"/>
              </a:ext>
            </a:extLst>
          </p:cNvPr>
          <p:cNvSpPr/>
          <p:nvPr/>
        </p:nvSpPr>
        <p:spPr>
          <a:xfrm>
            <a:off x="5388915" y="0"/>
            <a:ext cx="1469085" cy="101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844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53</Words>
  <Application>Microsoft Office PowerPoint</Application>
  <PresentationFormat>Letter Paper (8.5x11 in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nfacon, Helene (AAFC/AAC)</dc:creator>
  <cp:lastModifiedBy>Sanfacon, Helene (AAFC/AAC)</cp:lastModifiedBy>
  <cp:revision>1</cp:revision>
  <dcterms:created xsi:type="dcterms:W3CDTF">2025-04-10T15:23:56Z</dcterms:created>
  <dcterms:modified xsi:type="dcterms:W3CDTF">2025-06-12T19:1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4-10T15:26:52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41bae856-3b8a-41a7-b019-19130d4c5562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Office Theme:8</vt:lpwstr>
  </property>
  <property fmtid="{D5CDD505-2E9C-101B-9397-08002B2CF9AE}" pid="11" name="ClassificationContentMarkingHeaderText">
    <vt:lpwstr>Unclassified / Non classifié</vt:lpwstr>
  </property>
</Properties>
</file>